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427" y="5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022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794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189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292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4165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508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486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265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619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40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963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90083-3641-48C2-9DBE-88013318CB0A}" type="datetimeFigureOut">
              <a:rPr lang="en-US" smtClean="0"/>
              <a:pPr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5604A0-D627-410C-B3DA-54176C8EC30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3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57467" y="3384451"/>
            <a:ext cx="1089152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/>
              <a:t>Figure S1</a:t>
            </a:r>
            <a:r>
              <a:rPr lang="en-US" dirty="0"/>
              <a:t>. </a:t>
            </a:r>
            <a:r>
              <a:rPr lang="en-US" dirty="0"/>
              <a:t>Scanning electron microscopy images of </a:t>
            </a:r>
            <a:r>
              <a:rPr lang="en-US" i="1" dirty="0" err="1"/>
              <a:t>Bradyrhizobium</a:t>
            </a:r>
            <a:r>
              <a:rPr lang="en-US" i="1" dirty="0"/>
              <a:t> </a:t>
            </a:r>
            <a:r>
              <a:rPr lang="en-US" i="1" dirty="0" err="1"/>
              <a:t>japonicum</a:t>
            </a:r>
            <a:r>
              <a:rPr lang="en-US" dirty="0"/>
              <a:t>, </a:t>
            </a:r>
            <a:r>
              <a:rPr lang="en-US" i="1" dirty="0"/>
              <a:t>Micrococcus </a:t>
            </a:r>
            <a:r>
              <a:rPr lang="en-US" i="1" dirty="0" err="1"/>
              <a:t>luteus</a:t>
            </a:r>
            <a:r>
              <a:rPr lang="en-US" dirty="0"/>
              <a:t>, and </a:t>
            </a:r>
            <a:r>
              <a:rPr lang="en-US" i="1" dirty="0"/>
              <a:t>Bacillus cereus</a:t>
            </a:r>
            <a:endParaRPr lang="en-US" i="1" dirty="0">
              <a:latin typeface="Times New Roman" pitchFamily="18" charset="0"/>
              <a:ea typeface="Times New Roman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640306" y="298560"/>
            <a:ext cx="324128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230894" y="308720"/>
            <a:ext cx="331656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6568" y="677841"/>
            <a:ext cx="3616792" cy="271559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04480" y="672059"/>
            <a:ext cx="3629224" cy="271122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190" y="667104"/>
            <a:ext cx="3552890" cy="2726336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7918974" y="288400"/>
            <a:ext cx="331656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127252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20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is Nzila Mouanda</dc:creator>
  <cp:lastModifiedBy>Alexis Nzila Mouanda</cp:lastModifiedBy>
  <cp:revision>29</cp:revision>
  <dcterms:created xsi:type="dcterms:W3CDTF">2020-02-13T11:34:41Z</dcterms:created>
  <dcterms:modified xsi:type="dcterms:W3CDTF">2022-01-21T10:19:31Z</dcterms:modified>
</cp:coreProperties>
</file>